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B3A013-EE0D-4205-B199-37D97730BB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99D3A9-EDE5-4676-8031-64DBA4BC4D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6F00F0-BC4A-4779-AB2C-FDDC124DB5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8919D-626B-4799-BAE4-E0279D3D13B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672514-72DE-4E5D-B283-7F06E83248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1A450-4E8B-4FBE-A9C0-2C72C3F0C6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5FAD93-707D-4448-A8B3-664325EE59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E08DE6-5A5D-4149-A73C-09CB5AD391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C37AFD-B948-47BC-9DE9-9220670E6D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0E0977-BF4A-40D3-945B-4B86B9EBE9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E67628-DBFC-443B-883F-78728260E7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5527E8-1DFA-40D6-8CF8-F4B9F7F1C5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5E0940-BAA8-49FF-8A35-3311B5D60F01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500040" y="4478400"/>
            <a:ext cx="807264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le 2: </a:t>
            </a: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Human chromosome 4 DUB/USP17 family members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Phylogenetic tree of the identified human DUB/USP17 DNA sequences from chromosome 4 generated using a ClustalW2 alignmen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The sequence accession numbers are as follows; LOC100287144 (GenBank: XM_002342430); LOC100287178 (GenBank: XM_002342431); LOC100287205 (GenBank: XM_002342432); LOC100287238 (GenBank: XM_002342433); LOC100287270 (GenBank: XR_078301); LOC100288520 (GenBank: XM_002342445); LOC100287302 (GenBank: NC_000004 Region 9240856 to 9242448); LOC100287327 (GenBank: XM_002342434); LOC100287364 (GenBank: XM_002342435); LOC100287404 (GenBank: XM_002342436); LOC100287441 (GenBank: XM_002342437); LOC100287478 (GenBank: XM_002342438); LOC100287513 (GenBank: XM_002342439); LOC728369 (GenBank: XM_001130410); LOC728373 (GenBank: XM_001130417); LOC728379 (GenBank: XM_001130428); USP17L5 (GenBank: XM_001130437); LOC728393 (GenBank: XM_001130444); LOC728400 (GenBank: XM_001130452); LOC728405 (GenBank: XM_001130464); USP17 (GenBank: NM_001105662); LOC728419 (GenBank: XM_001130476); DUB4 (GenBank: NR_027279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3" descr=""/>
          <p:cNvPicPr/>
          <p:nvPr/>
        </p:nvPicPr>
        <p:blipFill>
          <a:blip r:embed="rId1"/>
          <a:srcRect l="25099" t="30472" r="13380" b="24611"/>
          <a:stretch/>
        </p:blipFill>
        <p:spPr>
          <a:xfrm>
            <a:off x="270000" y="71280"/>
            <a:ext cx="8088120" cy="4429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21T12:18:48Z</dcterms:created>
  <dc:creator>QUB</dc:creator>
  <dc:description/>
  <dc:language>en-US</dc:language>
  <cp:lastModifiedBy>QUB</cp:lastModifiedBy>
  <dcterms:modified xsi:type="dcterms:W3CDTF">2010-04-12T13:51:14Z</dcterms:modified>
  <cp:revision>3</cp:revision>
  <dc:subject/>
  <dc:title>Slide 1</dc:title>
</cp:coreProperties>
</file>